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6" r:id="rId2"/>
  </p:sldIdLst>
  <p:sldSz cx="11879263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 snapToObjects="1">
      <p:cViewPr>
        <p:scale>
          <a:sx n="36" d="100"/>
          <a:sy n="36" d="100"/>
        </p:scale>
        <p:origin x="1852" y="-4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90945" y="2356703"/>
            <a:ext cx="10097374" cy="5013407"/>
          </a:xfrm>
        </p:spPr>
        <p:txBody>
          <a:bodyPr anchor="b"/>
          <a:lstStyle>
            <a:lvl1pPr algn="ctr">
              <a:defRPr sz="779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4908" y="7563446"/>
            <a:ext cx="8909447" cy="3476717"/>
          </a:xfrm>
        </p:spPr>
        <p:txBody>
          <a:bodyPr/>
          <a:lstStyle>
            <a:lvl1pPr marL="0" indent="0" algn="ctr">
              <a:buNone/>
              <a:defRPr sz="3118"/>
            </a:lvl1pPr>
            <a:lvl2pPr marL="593949" indent="0" algn="ctr">
              <a:buNone/>
              <a:defRPr sz="2598"/>
            </a:lvl2pPr>
            <a:lvl3pPr marL="1187897" indent="0" algn="ctr">
              <a:buNone/>
              <a:defRPr sz="2338"/>
            </a:lvl3pPr>
            <a:lvl4pPr marL="1781846" indent="0" algn="ctr">
              <a:buNone/>
              <a:defRPr sz="2079"/>
            </a:lvl4pPr>
            <a:lvl5pPr marL="2375794" indent="0" algn="ctr">
              <a:buNone/>
              <a:defRPr sz="2079"/>
            </a:lvl5pPr>
            <a:lvl6pPr marL="2969743" indent="0" algn="ctr">
              <a:buNone/>
              <a:defRPr sz="2079"/>
            </a:lvl6pPr>
            <a:lvl7pPr marL="3563691" indent="0" algn="ctr">
              <a:buNone/>
              <a:defRPr sz="2079"/>
            </a:lvl7pPr>
            <a:lvl8pPr marL="4157640" indent="0" algn="ctr">
              <a:buNone/>
              <a:defRPr sz="2079"/>
            </a:lvl8pPr>
            <a:lvl9pPr marL="4751588" indent="0" algn="ctr">
              <a:buNone/>
              <a:defRPr sz="2079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18D8A-F640-EC43-BFA7-E29A5B681028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E6422-7377-8C4C-B68F-7EE051367D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4132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18D8A-F640-EC43-BFA7-E29A5B681028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E6422-7377-8C4C-B68F-7EE051367D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71915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501098" y="766678"/>
            <a:ext cx="2561466" cy="12203515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16700" y="766678"/>
            <a:ext cx="7535907" cy="12203515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18D8A-F640-EC43-BFA7-E29A5B681028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E6422-7377-8C4C-B68F-7EE051367D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59784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18D8A-F640-EC43-BFA7-E29A5B681028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E6422-7377-8C4C-B68F-7EE051367D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7959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0513" y="3590057"/>
            <a:ext cx="10245864" cy="5990088"/>
          </a:xfrm>
        </p:spPr>
        <p:txBody>
          <a:bodyPr anchor="b"/>
          <a:lstStyle>
            <a:lvl1pPr>
              <a:defRPr sz="779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0513" y="9636813"/>
            <a:ext cx="10245864" cy="3150046"/>
          </a:xfrm>
        </p:spPr>
        <p:txBody>
          <a:bodyPr/>
          <a:lstStyle>
            <a:lvl1pPr marL="0" indent="0">
              <a:buNone/>
              <a:defRPr sz="3118">
                <a:solidFill>
                  <a:schemeClr val="tx1"/>
                </a:solidFill>
              </a:defRPr>
            </a:lvl1pPr>
            <a:lvl2pPr marL="593949" indent="0">
              <a:buNone/>
              <a:defRPr sz="2598">
                <a:solidFill>
                  <a:schemeClr val="tx1">
                    <a:tint val="75000"/>
                  </a:schemeClr>
                </a:solidFill>
              </a:defRPr>
            </a:lvl2pPr>
            <a:lvl3pPr marL="1187897" indent="0">
              <a:buNone/>
              <a:defRPr sz="2338">
                <a:solidFill>
                  <a:schemeClr val="tx1">
                    <a:tint val="75000"/>
                  </a:schemeClr>
                </a:solidFill>
              </a:defRPr>
            </a:lvl3pPr>
            <a:lvl4pPr marL="1781846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4pPr>
            <a:lvl5pPr marL="2375794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5pPr>
            <a:lvl6pPr marL="2969743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6pPr>
            <a:lvl7pPr marL="3563691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7pPr>
            <a:lvl8pPr marL="4157640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8pPr>
            <a:lvl9pPr marL="4751588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18D8A-F640-EC43-BFA7-E29A5B681028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E6422-7377-8C4C-B68F-7EE051367D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9372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16699" y="3833390"/>
            <a:ext cx="5048687" cy="913680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13877" y="3833390"/>
            <a:ext cx="5048687" cy="913680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18D8A-F640-EC43-BFA7-E29A5B681028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E6422-7377-8C4C-B68F-7EE051367D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5753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247" y="766681"/>
            <a:ext cx="10245864" cy="2783376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8248" y="3530053"/>
            <a:ext cx="5025484" cy="1730025"/>
          </a:xfrm>
        </p:spPr>
        <p:txBody>
          <a:bodyPr anchor="b"/>
          <a:lstStyle>
            <a:lvl1pPr marL="0" indent="0">
              <a:buNone/>
              <a:defRPr sz="3118" b="1"/>
            </a:lvl1pPr>
            <a:lvl2pPr marL="593949" indent="0">
              <a:buNone/>
              <a:defRPr sz="2598" b="1"/>
            </a:lvl2pPr>
            <a:lvl3pPr marL="1187897" indent="0">
              <a:buNone/>
              <a:defRPr sz="2338" b="1"/>
            </a:lvl3pPr>
            <a:lvl4pPr marL="1781846" indent="0">
              <a:buNone/>
              <a:defRPr sz="2079" b="1"/>
            </a:lvl4pPr>
            <a:lvl5pPr marL="2375794" indent="0">
              <a:buNone/>
              <a:defRPr sz="2079" b="1"/>
            </a:lvl5pPr>
            <a:lvl6pPr marL="2969743" indent="0">
              <a:buNone/>
              <a:defRPr sz="2079" b="1"/>
            </a:lvl6pPr>
            <a:lvl7pPr marL="3563691" indent="0">
              <a:buNone/>
              <a:defRPr sz="2079" b="1"/>
            </a:lvl7pPr>
            <a:lvl8pPr marL="4157640" indent="0">
              <a:buNone/>
              <a:defRPr sz="2079" b="1"/>
            </a:lvl8pPr>
            <a:lvl9pPr marL="4751588" indent="0">
              <a:buNone/>
              <a:defRPr sz="2079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18248" y="5260078"/>
            <a:ext cx="5025484" cy="773678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013878" y="3530053"/>
            <a:ext cx="5050234" cy="1730025"/>
          </a:xfrm>
        </p:spPr>
        <p:txBody>
          <a:bodyPr anchor="b"/>
          <a:lstStyle>
            <a:lvl1pPr marL="0" indent="0">
              <a:buNone/>
              <a:defRPr sz="3118" b="1"/>
            </a:lvl1pPr>
            <a:lvl2pPr marL="593949" indent="0">
              <a:buNone/>
              <a:defRPr sz="2598" b="1"/>
            </a:lvl2pPr>
            <a:lvl3pPr marL="1187897" indent="0">
              <a:buNone/>
              <a:defRPr sz="2338" b="1"/>
            </a:lvl3pPr>
            <a:lvl4pPr marL="1781846" indent="0">
              <a:buNone/>
              <a:defRPr sz="2079" b="1"/>
            </a:lvl4pPr>
            <a:lvl5pPr marL="2375794" indent="0">
              <a:buNone/>
              <a:defRPr sz="2079" b="1"/>
            </a:lvl5pPr>
            <a:lvl6pPr marL="2969743" indent="0">
              <a:buNone/>
              <a:defRPr sz="2079" b="1"/>
            </a:lvl6pPr>
            <a:lvl7pPr marL="3563691" indent="0">
              <a:buNone/>
              <a:defRPr sz="2079" b="1"/>
            </a:lvl7pPr>
            <a:lvl8pPr marL="4157640" indent="0">
              <a:buNone/>
              <a:defRPr sz="2079" b="1"/>
            </a:lvl8pPr>
            <a:lvl9pPr marL="4751588" indent="0">
              <a:buNone/>
              <a:defRPr sz="2079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013878" y="5260078"/>
            <a:ext cx="5050234" cy="773678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18D8A-F640-EC43-BFA7-E29A5B681028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E6422-7377-8C4C-B68F-7EE051367D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0616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18D8A-F640-EC43-BFA7-E29A5B681028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E6422-7377-8C4C-B68F-7EE051367D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76555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18D8A-F640-EC43-BFA7-E29A5B681028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E6422-7377-8C4C-B68F-7EE051367D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9325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246" y="960014"/>
            <a:ext cx="3831372" cy="3360050"/>
          </a:xfrm>
        </p:spPr>
        <p:txBody>
          <a:bodyPr anchor="b"/>
          <a:lstStyle>
            <a:lvl1pPr>
              <a:defRPr sz="4157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050234" y="2073367"/>
            <a:ext cx="6013877" cy="10233485"/>
          </a:xfrm>
        </p:spPr>
        <p:txBody>
          <a:bodyPr/>
          <a:lstStyle>
            <a:lvl1pPr>
              <a:defRPr sz="4157"/>
            </a:lvl1pPr>
            <a:lvl2pPr>
              <a:defRPr sz="3637"/>
            </a:lvl2pPr>
            <a:lvl3pPr>
              <a:defRPr sz="3118"/>
            </a:lvl3pPr>
            <a:lvl4pPr>
              <a:defRPr sz="2598"/>
            </a:lvl4pPr>
            <a:lvl5pPr>
              <a:defRPr sz="2598"/>
            </a:lvl5pPr>
            <a:lvl6pPr>
              <a:defRPr sz="2598"/>
            </a:lvl6pPr>
            <a:lvl7pPr>
              <a:defRPr sz="2598"/>
            </a:lvl7pPr>
            <a:lvl8pPr>
              <a:defRPr sz="2598"/>
            </a:lvl8pPr>
            <a:lvl9pPr>
              <a:defRPr sz="2598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18246" y="4320064"/>
            <a:ext cx="3831372" cy="8003453"/>
          </a:xfrm>
        </p:spPr>
        <p:txBody>
          <a:bodyPr/>
          <a:lstStyle>
            <a:lvl1pPr marL="0" indent="0">
              <a:buNone/>
              <a:defRPr sz="2079"/>
            </a:lvl1pPr>
            <a:lvl2pPr marL="593949" indent="0">
              <a:buNone/>
              <a:defRPr sz="1819"/>
            </a:lvl2pPr>
            <a:lvl3pPr marL="1187897" indent="0">
              <a:buNone/>
              <a:defRPr sz="1559"/>
            </a:lvl3pPr>
            <a:lvl4pPr marL="1781846" indent="0">
              <a:buNone/>
              <a:defRPr sz="1299"/>
            </a:lvl4pPr>
            <a:lvl5pPr marL="2375794" indent="0">
              <a:buNone/>
              <a:defRPr sz="1299"/>
            </a:lvl5pPr>
            <a:lvl6pPr marL="2969743" indent="0">
              <a:buNone/>
              <a:defRPr sz="1299"/>
            </a:lvl6pPr>
            <a:lvl7pPr marL="3563691" indent="0">
              <a:buNone/>
              <a:defRPr sz="1299"/>
            </a:lvl7pPr>
            <a:lvl8pPr marL="4157640" indent="0">
              <a:buNone/>
              <a:defRPr sz="1299"/>
            </a:lvl8pPr>
            <a:lvl9pPr marL="4751588" indent="0">
              <a:buNone/>
              <a:defRPr sz="129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18D8A-F640-EC43-BFA7-E29A5B681028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E6422-7377-8C4C-B68F-7EE051367D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1396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246" y="960014"/>
            <a:ext cx="3831372" cy="3360050"/>
          </a:xfrm>
        </p:spPr>
        <p:txBody>
          <a:bodyPr anchor="b"/>
          <a:lstStyle>
            <a:lvl1pPr>
              <a:defRPr sz="4157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050234" y="2073367"/>
            <a:ext cx="6013877" cy="10233485"/>
          </a:xfrm>
        </p:spPr>
        <p:txBody>
          <a:bodyPr anchor="t"/>
          <a:lstStyle>
            <a:lvl1pPr marL="0" indent="0">
              <a:buNone/>
              <a:defRPr sz="4157"/>
            </a:lvl1pPr>
            <a:lvl2pPr marL="593949" indent="0">
              <a:buNone/>
              <a:defRPr sz="3637"/>
            </a:lvl2pPr>
            <a:lvl3pPr marL="1187897" indent="0">
              <a:buNone/>
              <a:defRPr sz="3118"/>
            </a:lvl3pPr>
            <a:lvl4pPr marL="1781846" indent="0">
              <a:buNone/>
              <a:defRPr sz="2598"/>
            </a:lvl4pPr>
            <a:lvl5pPr marL="2375794" indent="0">
              <a:buNone/>
              <a:defRPr sz="2598"/>
            </a:lvl5pPr>
            <a:lvl6pPr marL="2969743" indent="0">
              <a:buNone/>
              <a:defRPr sz="2598"/>
            </a:lvl6pPr>
            <a:lvl7pPr marL="3563691" indent="0">
              <a:buNone/>
              <a:defRPr sz="2598"/>
            </a:lvl7pPr>
            <a:lvl8pPr marL="4157640" indent="0">
              <a:buNone/>
              <a:defRPr sz="2598"/>
            </a:lvl8pPr>
            <a:lvl9pPr marL="4751588" indent="0">
              <a:buNone/>
              <a:defRPr sz="2598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18246" y="4320064"/>
            <a:ext cx="3831372" cy="8003453"/>
          </a:xfrm>
        </p:spPr>
        <p:txBody>
          <a:bodyPr/>
          <a:lstStyle>
            <a:lvl1pPr marL="0" indent="0">
              <a:buNone/>
              <a:defRPr sz="2079"/>
            </a:lvl1pPr>
            <a:lvl2pPr marL="593949" indent="0">
              <a:buNone/>
              <a:defRPr sz="1819"/>
            </a:lvl2pPr>
            <a:lvl3pPr marL="1187897" indent="0">
              <a:buNone/>
              <a:defRPr sz="1559"/>
            </a:lvl3pPr>
            <a:lvl4pPr marL="1781846" indent="0">
              <a:buNone/>
              <a:defRPr sz="1299"/>
            </a:lvl4pPr>
            <a:lvl5pPr marL="2375794" indent="0">
              <a:buNone/>
              <a:defRPr sz="1299"/>
            </a:lvl5pPr>
            <a:lvl6pPr marL="2969743" indent="0">
              <a:buNone/>
              <a:defRPr sz="1299"/>
            </a:lvl6pPr>
            <a:lvl7pPr marL="3563691" indent="0">
              <a:buNone/>
              <a:defRPr sz="1299"/>
            </a:lvl7pPr>
            <a:lvl8pPr marL="4157640" indent="0">
              <a:buNone/>
              <a:defRPr sz="1299"/>
            </a:lvl8pPr>
            <a:lvl9pPr marL="4751588" indent="0">
              <a:buNone/>
              <a:defRPr sz="129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18D8A-F640-EC43-BFA7-E29A5B681028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CE6422-7377-8C4C-B68F-7EE051367D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99783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16700" y="766681"/>
            <a:ext cx="10245864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6700" y="3833390"/>
            <a:ext cx="10245864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16699" y="13346867"/>
            <a:ext cx="2672834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5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A18D8A-F640-EC43-BFA7-E29A5B681028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935006" y="13346867"/>
            <a:ext cx="4009251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5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389730" y="13346867"/>
            <a:ext cx="2672834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5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CE6422-7377-8C4C-B68F-7EE051367D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92739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187897" rtl="0" eaLnBrk="1" latinLnBrk="0" hangingPunct="1">
        <a:lnSpc>
          <a:spcPct val="90000"/>
        </a:lnSpc>
        <a:spcBef>
          <a:spcPct val="0"/>
        </a:spcBef>
        <a:buNone/>
        <a:defRPr sz="571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6974" indent="-296974" algn="l" defTabSz="1187897" rtl="0" eaLnBrk="1" latinLnBrk="0" hangingPunct="1">
        <a:lnSpc>
          <a:spcPct val="90000"/>
        </a:lnSpc>
        <a:spcBef>
          <a:spcPts val="1299"/>
        </a:spcBef>
        <a:buFont typeface="Arial" panose="020B0604020202020204" pitchFamily="34" charset="0"/>
        <a:buChar char="•"/>
        <a:defRPr sz="3637" kern="1200">
          <a:solidFill>
            <a:schemeClr val="tx1"/>
          </a:solidFill>
          <a:latin typeface="+mn-lt"/>
          <a:ea typeface="+mn-ea"/>
          <a:cs typeface="+mn-cs"/>
        </a:defRPr>
      </a:lvl1pPr>
      <a:lvl2pPr marL="890923" indent="-296974" algn="l" defTabSz="1187897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3118" kern="1200">
          <a:solidFill>
            <a:schemeClr val="tx1"/>
          </a:solidFill>
          <a:latin typeface="+mn-lt"/>
          <a:ea typeface="+mn-ea"/>
          <a:cs typeface="+mn-cs"/>
        </a:defRPr>
      </a:lvl2pPr>
      <a:lvl3pPr marL="1484871" indent="-296974" algn="l" defTabSz="1187897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598" kern="1200">
          <a:solidFill>
            <a:schemeClr val="tx1"/>
          </a:solidFill>
          <a:latin typeface="+mn-lt"/>
          <a:ea typeface="+mn-ea"/>
          <a:cs typeface="+mn-cs"/>
        </a:defRPr>
      </a:lvl3pPr>
      <a:lvl4pPr marL="2078820" indent="-296974" algn="l" defTabSz="1187897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38" kern="1200">
          <a:solidFill>
            <a:schemeClr val="tx1"/>
          </a:solidFill>
          <a:latin typeface="+mn-lt"/>
          <a:ea typeface="+mn-ea"/>
          <a:cs typeface="+mn-cs"/>
        </a:defRPr>
      </a:lvl4pPr>
      <a:lvl5pPr marL="2672768" indent="-296974" algn="l" defTabSz="1187897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38" kern="1200">
          <a:solidFill>
            <a:schemeClr val="tx1"/>
          </a:solidFill>
          <a:latin typeface="+mn-lt"/>
          <a:ea typeface="+mn-ea"/>
          <a:cs typeface="+mn-cs"/>
        </a:defRPr>
      </a:lvl5pPr>
      <a:lvl6pPr marL="3266717" indent="-296974" algn="l" defTabSz="1187897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38" kern="1200">
          <a:solidFill>
            <a:schemeClr val="tx1"/>
          </a:solidFill>
          <a:latin typeface="+mn-lt"/>
          <a:ea typeface="+mn-ea"/>
          <a:cs typeface="+mn-cs"/>
        </a:defRPr>
      </a:lvl6pPr>
      <a:lvl7pPr marL="3860665" indent="-296974" algn="l" defTabSz="1187897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38" kern="1200">
          <a:solidFill>
            <a:schemeClr val="tx1"/>
          </a:solidFill>
          <a:latin typeface="+mn-lt"/>
          <a:ea typeface="+mn-ea"/>
          <a:cs typeface="+mn-cs"/>
        </a:defRPr>
      </a:lvl7pPr>
      <a:lvl8pPr marL="4454614" indent="-296974" algn="l" defTabSz="1187897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38" kern="1200">
          <a:solidFill>
            <a:schemeClr val="tx1"/>
          </a:solidFill>
          <a:latin typeface="+mn-lt"/>
          <a:ea typeface="+mn-ea"/>
          <a:cs typeface="+mn-cs"/>
        </a:defRPr>
      </a:lvl8pPr>
      <a:lvl9pPr marL="5048562" indent="-296974" algn="l" defTabSz="1187897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3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1pPr>
      <a:lvl2pPr marL="593949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2pPr>
      <a:lvl3pPr marL="1187897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3pPr>
      <a:lvl4pPr marL="1781846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4pPr>
      <a:lvl5pPr marL="2375794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5pPr>
      <a:lvl6pPr marL="2969743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6pPr>
      <a:lvl7pPr marL="3563691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7pPr>
      <a:lvl8pPr marL="4157640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8pPr>
      <a:lvl9pPr marL="4751588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4314ECE6-90CC-4355-8CC4-A50BAA17038E}"/>
              </a:ext>
            </a:extLst>
          </p:cNvPr>
          <p:cNvGrpSpPr/>
          <p:nvPr/>
        </p:nvGrpSpPr>
        <p:grpSpPr>
          <a:xfrm>
            <a:off x="1155" y="318997"/>
            <a:ext cx="11371684" cy="13076106"/>
            <a:chOff x="1155" y="318997"/>
            <a:chExt cx="11371684" cy="13076106"/>
          </a:xfrm>
        </p:grpSpPr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AA8EA6A5-1FF6-43E4-9CD7-A04CAD81517D}"/>
                </a:ext>
              </a:extLst>
            </p:cNvPr>
            <p:cNvGrpSpPr/>
            <p:nvPr/>
          </p:nvGrpSpPr>
          <p:grpSpPr>
            <a:xfrm>
              <a:off x="522985" y="1720449"/>
              <a:ext cx="10849854" cy="11674654"/>
              <a:chOff x="127561" y="1720449"/>
              <a:chExt cx="10849854" cy="11674654"/>
            </a:xfrm>
          </p:grpSpPr>
          <p:grpSp>
            <p:nvGrpSpPr>
              <p:cNvPr id="19" name="Group 18">
                <a:extLst>
                  <a:ext uri="{FF2B5EF4-FFF2-40B4-BE49-F238E27FC236}">
                    <a16:creationId xmlns:a16="http://schemas.microsoft.com/office/drawing/2014/main" id="{18DB9BB8-5273-477D-AC60-506CC75F0117}"/>
                  </a:ext>
                </a:extLst>
              </p:cNvPr>
              <p:cNvGrpSpPr/>
              <p:nvPr/>
            </p:nvGrpSpPr>
            <p:grpSpPr>
              <a:xfrm>
                <a:off x="1262741" y="1720449"/>
                <a:ext cx="9714674" cy="11674654"/>
                <a:chOff x="1262741" y="1720449"/>
                <a:chExt cx="9714674" cy="11674654"/>
              </a:xfrm>
            </p:grpSpPr>
            <p:grpSp>
              <p:nvGrpSpPr>
                <p:cNvPr id="6" name="Group 5">
                  <a:extLst>
                    <a:ext uri="{FF2B5EF4-FFF2-40B4-BE49-F238E27FC236}">
                      <a16:creationId xmlns:a16="http://schemas.microsoft.com/office/drawing/2014/main" id="{B9E3A09C-113F-024B-82CB-CE45DAF066CF}"/>
                    </a:ext>
                  </a:extLst>
                </p:cNvPr>
                <p:cNvGrpSpPr/>
                <p:nvPr/>
              </p:nvGrpSpPr>
              <p:grpSpPr>
                <a:xfrm>
                  <a:off x="1262741" y="1720449"/>
                  <a:ext cx="9714674" cy="11674654"/>
                  <a:chOff x="1317215" y="1691122"/>
                  <a:chExt cx="9714674" cy="11674654"/>
                </a:xfrm>
              </p:grpSpPr>
              <p:sp>
                <p:nvSpPr>
                  <p:cNvPr id="37" name="Rectangle 36">
                    <a:extLst>
                      <a:ext uri="{FF2B5EF4-FFF2-40B4-BE49-F238E27FC236}">
                        <a16:creationId xmlns:a16="http://schemas.microsoft.com/office/drawing/2014/main" id="{DB062C1D-1CEF-D141-9D9E-FB4DB6FD59A7}"/>
                      </a:ext>
                    </a:extLst>
                  </p:cNvPr>
                  <p:cNvSpPr/>
                  <p:nvPr/>
                </p:nvSpPr>
                <p:spPr>
                  <a:xfrm>
                    <a:off x="1317215" y="1691122"/>
                    <a:ext cx="9714674" cy="11557832"/>
                  </a:xfrm>
                  <a:prstGeom prst="rect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6"/>
                  </a:lnRef>
                  <a:fillRef idx="1">
                    <a:schemeClr val="lt1"/>
                  </a:fillRef>
                  <a:effectRef idx="0">
                    <a:schemeClr val="accent6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485" dirty="0"/>
                  </a:p>
                </p:txBody>
              </p:sp>
              <p:pic>
                <p:nvPicPr>
                  <p:cNvPr id="2" name="Picture 1">
                    <a:extLst>
                      <a:ext uri="{FF2B5EF4-FFF2-40B4-BE49-F238E27FC236}">
                        <a16:creationId xmlns:a16="http://schemas.microsoft.com/office/drawing/2014/main" id="{58C7AA9F-F408-8543-ABDF-019CB62999E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/>
                  <a:stretch>
                    <a:fillRect/>
                  </a:stretch>
                </p:blipFill>
                <p:spPr>
                  <a:xfrm>
                    <a:off x="1317215" y="1691123"/>
                    <a:ext cx="9714674" cy="11674653"/>
                  </a:xfrm>
                  <a:prstGeom prst="rect">
                    <a:avLst/>
                  </a:prstGeom>
                  <a:ln>
                    <a:noFill/>
                    <a:tailEnd type="triangle"/>
                  </a:ln>
                </p:spPr>
              </p:pic>
              <p:sp>
                <p:nvSpPr>
                  <p:cNvPr id="4" name="Rectangle 3">
                    <a:extLst>
                      <a:ext uri="{FF2B5EF4-FFF2-40B4-BE49-F238E27FC236}">
                        <a16:creationId xmlns:a16="http://schemas.microsoft.com/office/drawing/2014/main" id="{10AE6D7A-B735-AC43-A57C-67C619087920}"/>
                      </a:ext>
                    </a:extLst>
                  </p:cNvPr>
                  <p:cNvSpPr/>
                  <p:nvPr/>
                </p:nvSpPr>
                <p:spPr>
                  <a:xfrm>
                    <a:off x="5123370" y="11753193"/>
                    <a:ext cx="1044619" cy="1495761"/>
                  </a:xfrm>
                  <a:prstGeom prst="rect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6"/>
                  </a:lnRef>
                  <a:fillRef idx="1">
                    <a:schemeClr val="lt1"/>
                  </a:fillRef>
                  <a:effectRef idx="0">
                    <a:schemeClr val="accent6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485" dirty="0"/>
                  </a:p>
                </p:txBody>
              </p:sp>
            </p:grpSp>
            <p:grpSp>
              <p:nvGrpSpPr>
                <p:cNvPr id="13" name="Group 12">
                  <a:extLst>
                    <a:ext uri="{FF2B5EF4-FFF2-40B4-BE49-F238E27FC236}">
                      <a16:creationId xmlns:a16="http://schemas.microsoft.com/office/drawing/2014/main" id="{1C41C415-2D62-4B9D-83BB-48157B44DE93}"/>
                    </a:ext>
                  </a:extLst>
                </p:cNvPr>
                <p:cNvGrpSpPr/>
                <p:nvPr/>
              </p:nvGrpSpPr>
              <p:grpSpPr>
                <a:xfrm>
                  <a:off x="8474794" y="1720450"/>
                  <a:ext cx="1905592" cy="1634027"/>
                  <a:chOff x="8599439" y="8055805"/>
                  <a:chExt cx="1905592" cy="1634027"/>
                </a:xfrm>
              </p:grpSpPr>
              <p:grpSp>
                <p:nvGrpSpPr>
                  <p:cNvPr id="11" name="Group 10">
                    <a:extLst>
                      <a:ext uri="{FF2B5EF4-FFF2-40B4-BE49-F238E27FC236}">
                        <a16:creationId xmlns:a16="http://schemas.microsoft.com/office/drawing/2014/main" id="{E96B2D92-09BF-4AFF-956F-BB6FF90D4427}"/>
                      </a:ext>
                    </a:extLst>
                  </p:cNvPr>
                  <p:cNvGrpSpPr/>
                  <p:nvPr/>
                </p:nvGrpSpPr>
                <p:grpSpPr>
                  <a:xfrm>
                    <a:off x="9037677" y="8389326"/>
                    <a:ext cx="1041991" cy="978195"/>
                    <a:chOff x="7868093" y="12546419"/>
                    <a:chExt cx="1041991" cy="978195"/>
                  </a:xfrm>
                </p:grpSpPr>
                <p:cxnSp>
                  <p:nvCxnSpPr>
                    <p:cNvPr id="5" name="Straight Arrow Connector 4">
                      <a:extLst>
                        <a:ext uri="{FF2B5EF4-FFF2-40B4-BE49-F238E27FC236}">
                          <a16:creationId xmlns:a16="http://schemas.microsoft.com/office/drawing/2014/main" id="{F8B4BCAA-7EEA-4F87-8F04-7F6AF342F7C9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8399721" y="12546419"/>
                      <a:ext cx="0" cy="978195"/>
                    </a:xfrm>
                    <a:prstGeom prst="straightConnector1">
                      <a:avLst/>
                    </a:prstGeom>
                    <a:ln w="9525">
                      <a:solidFill>
                        <a:schemeClr val="tx1"/>
                      </a:solidFill>
                      <a:headEnd type="triangle"/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" name="Straight Arrow Connector 7">
                      <a:extLst>
                        <a:ext uri="{FF2B5EF4-FFF2-40B4-BE49-F238E27FC236}">
                          <a16:creationId xmlns:a16="http://schemas.microsoft.com/office/drawing/2014/main" id="{DADFEB55-4E17-463C-9CE9-92851C3B45C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7868093" y="12992986"/>
                      <a:ext cx="1041991" cy="0"/>
                    </a:xfrm>
                    <a:prstGeom prst="straightConnector1">
                      <a:avLst/>
                    </a:prstGeom>
                    <a:ln w="9525">
                      <a:solidFill>
                        <a:schemeClr val="tx1"/>
                      </a:solidFill>
                      <a:headEnd type="triangle"/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2" name="TextBox 11">
                    <a:extLst>
                      <a:ext uri="{FF2B5EF4-FFF2-40B4-BE49-F238E27FC236}">
                        <a16:creationId xmlns:a16="http://schemas.microsoft.com/office/drawing/2014/main" id="{D3C1DD20-2A6C-49F3-8B84-F2D839148D70}"/>
                      </a:ext>
                    </a:extLst>
                  </p:cNvPr>
                  <p:cNvSpPr txBox="1"/>
                  <p:nvPr/>
                </p:nvSpPr>
                <p:spPr>
                  <a:xfrm>
                    <a:off x="9268262" y="8055805"/>
                    <a:ext cx="63129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/>
                      <a:t>N</a:t>
                    </a:r>
                    <a:endParaRPr lang="en-IN" b="1" dirty="0"/>
                  </a:p>
                </p:txBody>
              </p:sp>
              <p:sp>
                <p:nvSpPr>
                  <p:cNvPr id="15" name="TextBox 14">
                    <a:extLst>
                      <a:ext uri="{FF2B5EF4-FFF2-40B4-BE49-F238E27FC236}">
                        <a16:creationId xmlns:a16="http://schemas.microsoft.com/office/drawing/2014/main" id="{2693C475-04E8-4D95-AF93-F4515818555D}"/>
                      </a:ext>
                    </a:extLst>
                  </p:cNvPr>
                  <p:cNvSpPr txBox="1"/>
                  <p:nvPr/>
                </p:nvSpPr>
                <p:spPr>
                  <a:xfrm>
                    <a:off x="9268262" y="9320500"/>
                    <a:ext cx="63129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/>
                      <a:t>S</a:t>
                    </a:r>
                    <a:endParaRPr lang="en-IN" b="1" dirty="0"/>
                  </a:p>
                </p:txBody>
              </p:sp>
              <p:sp>
                <p:nvSpPr>
                  <p:cNvPr id="16" name="TextBox 15">
                    <a:extLst>
                      <a:ext uri="{FF2B5EF4-FFF2-40B4-BE49-F238E27FC236}">
                        <a16:creationId xmlns:a16="http://schemas.microsoft.com/office/drawing/2014/main" id="{BABB79AF-10C7-4E30-B835-251B80063DCE}"/>
                      </a:ext>
                    </a:extLst>
                  </p:cNvPr>
                  <p:cNvSpPr txBox="1"/>
                  <p:nvPr/>
                </p:nvSpPr>
                <p:spPr>
                  <a:xfrm>
                    <a:off x="8599439" y="8653770"/>
                    <a:ext cx="63129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/>
                      <a:t>W</a:t>
                    </a:r>
                    <a:endParaRPr lang="en-IN" b="1" dirty="0"/>
                  </a:p>
                </p:txBody>
              </p:sp>
              <p:sp>
                <p:nvSpPr>
                  <p:cNvPr id="17" name="TextBox 16">
                    <a:extLst>
                      <a:ext uri="{FF2B5EF4-FFF2-40B4-BE49-F238E27FC236}">
                        <a16:creationId xmlns:a16="http://schemas.microsoft.com/office/drawing/2014/main" id="{735DEFA0-A89A-4219-A4F4-2662641D3D36}"/>
                      </a:ext>
                    </a:extLst>
                  </p:cNvPr>
                  <p:cNvSpPr txBox="1"/>
                  <p:nvPr/>
                </p:nvSpPr>
                <p:spPr>
                  <a:xfrm>
                    <a:off x="9873741" y="8642840"/>
                    <a:ext cx="63129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b="1" dirty="0"/>
                      <a:t>E</a:t>
                    </a:r>
                    <a:endParaRPr lang="en-IN" b="1" dirty="0"/>
                  </a:p>
                </p:txBody>
              </p:sp>
            </p:grpSp>
            <p:sp>
              <p:nvSpPr>
                <p:cNvPr id="18" name="Star: 5 Points 17">
                  <a:extLst>
                    <a:ext uri="{FF2B5EF4-FFF2-40B4-BE49-F238E27FC236}">
                      <a16:creationId xmlns:a16="http://schemas.microsoft.com/office/drawing/2014/main" id="{7E0A1857-F973-4A12-85FC-0B8E863EE24B}"/>
                    </a:ext>
                  </a:extLst>
                </p:cNvPr>
                <p:cNvSpPr/>
                <p:nvPr/>
              </p:nvSpPr>
              <p:spPr>
                <a:xfrm>
                  <a:off x="6745122" y="7200106"/>
                  <a:ext cx="340242" cy="361507"/>
                </a:xfrm>
                <a:prstGeom prst="star5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0" name="Star: 5 Points 19">
                  <a:extLst>
                    <a:ext uri="{FF2B5EF4-FFF2-40B4-BE49-F238E27FC236}">
                      <a16:creationId xmlns:a16="http://schemas.microsoft.com/office/drawing/2014/main" id="{2A697696-9762-4635-B930-6C579344FC4A}"/>
                    </a:ext>
                  </a:extLst>
                </p:cNvPr>
                <p:cNvSpPr/>
                <p:nvPr/>
              </p:nvSpPr>
              <p:spPr>
                <a:xfrm>
                  <a:off x="2300177" y="6838599"/>
                  <a:ext cx="340242" cy="361507"/>
                </a:xfrm>
                <a:prstGeom prst="star5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1" name="Star: 5 Points 20">
                  <a:extLst>
                    <a:ext uri="{FF2B5EF4-FFF2-40B4-BE49-F238E27FC236}">
                      <a16:creationId xmlns:a16="http://schemas.microsoft.com/office/drawing/2014/main" id="{6A985746-6F06-4741-9BDE-7650E0859128}"/>
                    </a:ext>
                  </a:extLst>
                </p:cNvPr>
                <p:cNvSpPr/>
                <p:nvPr/>
              </p:nvSpPr>
              <p:spPr>
                <a:xfrm>
                  <a:off x="4782462" y="10618381"/>
                  <a:ext cx="340242" cy="361507"/>
                </a:xfrm>
                <a:prstGeom prst="star5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</p:grp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6A1CC015-1798-42A1-8AD0-5469BF71021C}"/>
                  </a:ext>
                </a:extLst>
              </p:cNvPr>
              <p:cNvSpPr txBox="1"/>
              <p:nvPr/>
            </p:nvSpPr>
            <p:spPr>
              <a:xfrm>
                <a:off x="7947136" y="7684628"/>
                <a:ext cx="2433250" cy="14773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b="1" dirty="0"/>
                  <a:t>Rourkela</a:t>
                </a:r>
              </a:p>
              <a:p>
                <a:pPr algn="just"/>
                <a:endParaRPr lang="en-US" dirty="0"/>
              </a:p>
              <a:p>
                <a:r>
                  <a:rPr lang="en-US" dirty="0"/>
                  <a:t>Rural/Tribal/Peri-urban Meso-High endemic </a:t>
                </a:r>
                <a:r>
                  <a:rPr lang="en-US" i="1" dirty="0"/>
                  <a:t>P. falciparum </a:t>
                </a:r>
                <a:r>
                  <a:rPr lang="en-US" dirty="0"/>
                  <a:t>dominant</a:t>
                </a:r>
                <a:endParaRPr lang="en-IN" dirty="0"/>
              </a:p>
            </p:txBody>
          </p:sp>
          <p:cxnSp>
            <p:nvCxnSpPr>
              <p:cNvPr id="24" name="Straight Arrow Connector 23">
                <a:extLst>
                  <a:ext uri="{FF2B5EF4-FFF2-40B4-BE49-F238E27FC236}">
                    <a16:creationId xmlns:a16="http://schemas.microsoft.com/office/drawing/2014/main" id="{1DD1EA05-B3AC-4D95-B6B1-ABDE4304C476}"/>
                  </a:ext>
                </a:extLst>
              </p:cNvPr>
              <p:cNvCxnSpPr/>
              <p:nvPr/>
            </p:nvCxnSpPr>
            <p:spPr>
              <a:xfrm>
                <a:off x="7085364" y="7499365"/>
                <a:ext cx="1389430" cy="373396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266E31A1-830F-4004-80B2-4AE544B5C354}"/>
                  </a:ext>
                </a:extLst>
              </p:cNvPr>
              <p:cNvSpPr txBox="1"/>
              <p:nvPr/>
            </p:nvSpPr>
            <p:spPr>
              <a:xfrm>
                <a:off x="5732162" y="10618381"/>
                <a:ext cx="2742631" cy="120032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b="1" dirty="0"/>
                  <a:t>Chennai</a:t>
                </a:r>
              </a:p>
              <a:p>
                <a:pPr algn="just"/>
                <a:endParaRPr lang="en-US" dirty="0"/>
              </a:p>
              <a:p>
                <a:r>
                  <a:rPr lang="en-US" dirty="0"/>
                  <a:t>Urban Meso-High endemic </a:t>
                </a:r>
                <a:r>
                  <a:rPr lang="en-US" i="1" dirty="0"/>
                  <a:t>P. vivax </a:t>
                </a:r>
                <a:r>
                  <a:rPr lang="en-US" dirty="0"/>
                  <a:t>dominant</a:t>
                </a:r>
                <a:endParaRPr lang="en-IN" dirty="0"/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04CD3EE6-7A48-4C4E-979C-33530249D1B3}"/>
                  </a:ext>
                </a:extLst>
              </p:cNvPr>
              <p:cNvSpPr txBox="1"/>
              <p:nvPr/>
            </p:nvSpPr>
            <p:spPr>
              <a:xfrm>
                <a:off x="127561" y="7877386"/>
                <a:ext cx="2742631" cy="120032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b="1" dirty="0"/>
                  <a:t>Nadiad</a:t>
                </a:r>
              </a:p>
              <a:p>
                <a:pPr algn="just"/>
                <a:endParaRPr lang="en-US" dirty="0"/>
              </a:p>
              <a:p>
                <a:r>
                  <a:rPr lang="en-US" dirty="0"/>
                  <a:t>Rural/Peri-urban Low endemic </a:t>
                </a:r>
                <a:r>
                  <a:rPr lang="en-US" i="1" dirty="0"/>
                  <a:t>P. vivax </a:t>
                </a:r>
                <a:r>
                  <a:rPr lang="en-US" dirty="0"/>
                  <a:t>dominant</a:t>
                </a:r>
                <a:endParaRPr lang="en-IN" dirty="0"/>
              </a:p>
            </p:txBody>
          </p:sp>
          <p:cxnSp>
            <p:nvCxnSpPr>
              <p:cNvPr id="28" name="Straight Arrow Connector 27">
                <a:extLst>
                  <a:ext uri="{FF2B5EF4-FFF2-40B4-BE49-F238E27FC236}">
                    <a16:creationId xmlns:a16="http://schemas.microsoft.com/office/drawing/2014/main" id="{0827E61F-F3F5-41ED-8956-52B623D32411}"/>
                  </a:ext>
                </a:extLst>
              </p:cNvPr>
              <p:cNvCxnSpPr/>
              <p:nvPr/>
            </p:nvCxnSpPr>
            <p:spPr>
              <a:xfrm>
                <a:off x="5122704" y="10823774"/>
                <a:ext cx="1322701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Arrow Connector 29">
                <a:extLst>
                  <a:ext uri="{FF2B5EF4-FFF2-40B4-BE49-F238E27FC236}">
                    <a16:creationId xmlns:a16="http://schemas.microsoft.com/office/drawing/2014/main" id="{E58D1E44-71F6-4FFF-99E7-3458C621A793}"/>
                  </a:ext>
                </a:extLst>
              </p:cNvPr>
              <p:cNvCxnSpPr>
                <a:cxnSpLocks/>
                <a:endCxn id="27" idx="0"/>
              </p:cNvCxnSpPr>
              <p:nvPr/>
            </p:nvCxnSpPr>
            <p:spPr>
              <a:xfrm flipH="1">
                <a:off x="1498877" y="7247047"/>
                <a:ext cx="801302" cy="630339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0C5C7FE4-A876-437E-90F3-DBC54C9C8791}"/>
                </a:ext>
              </a:extLst>
            </p:cNvPr>
            <p:cNvSpPr/>
            <p:nvPr/>
          </p:nvSpPr>
          <p:spPr>
            <a:xfrm>
              <a:off x="1155" y="318997"/>
              <a:ext cx="8950592" cy="6147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>
                <a:lnSpc>
                  <a:spcPct val="200000"/>
                </a:lnSpc>
                <a:spcAft>
                  <a:spcPts val="0"/>
                </a:spcAft>
              </a:pPr>
              <a:r>
                <a:rPr lang="en-US" sz="2000" b="1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1 Fig. </a:t>
              </a:r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ographical map of India </a:t>
              </a:r>
              <a:r>
                <a:rPr lang="en-GB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map drawn by Author)</a:t>
              </a:r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b="1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howing the three study sites</a:t>
              </a:r>
              <a:endParaRPr lang="en-IN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571385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</TotalTime>
  <Words>52</Words>
  <Application>Microsoft Office PowerPoint</Application>
  <PresentationFormat>Custom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m Singh</dc:creator>
  <cp:lastModifiedBy>Prashant Mallick</cp:lastModifiedBy>
  <cp:revision>6</cp:revision>
  <dcterms:created xsi:type="dcterms:W3CDTF">2021-07-30T09:02:21Z</dcterms:created>
  <dcterms:modified xsi:type="dcterms:W3CDTF">2021-08-04T04:27:50Z</dcterms:modified>
</cp:coreProperties>
</file>